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67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9B122F-F77A-444A-B520-4119BC3307A8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3B40A5-0611-402F-A8A3-ABBF1AEC188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0170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FB1BA0-936A-DF02-ED08-50DAF1F3A1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E61DEC7-DE22-0423-3E27-4466F441FAA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B2C431-303A-D951-5673-4E8A2A77EC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64C896-8502-3F36-C7C1-FC643B5A8B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DA1253-708A-4ED2-CE0D-64592CCA6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3974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4D61EF-01CB-E40E-4FB8-32D3417AD5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FC2575-CFDE-187E-444F-76CB15E05D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BD2737-ED31-434C-6256-21C5F36B85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34EA6C-F631-482C-8347-0C4D3E4F54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CE2A1A-B8FE-FB31-5953-64940424C4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40356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C43B43F-DCD5-80F5-098D-2AD389959EF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9260F0-E4F8-6B04-BFEC-32565F1728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4C6089-8041-E51A-AC66-D603E06170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25958D-35BA-410C-496D-33A52094AA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8F7A2D-3432-2E4A-CF0A-7B1A5399F0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08420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2002E1-F760-9DC3-FBB0-2078A60963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7F2118-AD94-4BF6-2715-2B5D163693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C7655C-567C-D7EC-086E-351DEE86C3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69A1E9-BF2F-BF73-1B59-5DD440A7BB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E55E37-AE81-678A-D750-08BF00EC16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8341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E8C769-18E8-62B9-A159-6570E8A78C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E66848-19EE-C14A-AB97-1294806CB2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3671CB-16C5-7ABF-C5DD-CD9616574F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94E9F3-5405-2B15-5BC4-245CAB15A4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929467-33CC-3224-A00B-33A0BCD30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7928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2877E1-B9F2-9FA1-485D-BFAD04C28A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9A4B8F-0896-FB51-AC0E-8B230764CEE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A6C18F-1DED-4CDF-8409-88C737AE6C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03DC38-2328-012C-A046-AC2C775A71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0BA32E-4C84-B011-A24B-026F701329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03EC52-705C-91CE-4391-C5D471C31B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3488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E15206-4239-DBAB-F5CD-9FE1A77B03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0B1A4B-C7E9-30E3-F1F9-7190D20CE0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6EA6A51-D19C-2528-07EE-F21394A3AC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551918B-F1A6-FAB1-0C64-EC5CF9DFAD2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37E2159-E434-D6E5-7BAB-3029C91847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58875EC-6582-5693-F31A-04E3D77D83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A4CDC8F-B3D4-901F-393E-C1D7F5F7B6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3E68615-D49E-20FE-A917-8FB8543521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5614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E86584-CE89-2BE6-2FE8-4A2B32F3F4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1E29BE8-A7C3-1801-D71F-71AA04DDC8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5ADA298-D4A5-1A25-57F1-D4DA76F22F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60F087E-FCAB-34C4-795C-D1ED88E0BD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0908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8E4BDE2-2B73-0EEE-4885-AB856804BD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350EF5B-4421-B9A8-3954-9500615ACB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EB05F5B-83F8-8E3E-4AA8-20EC1D2EEA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6204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50ACA7-4D9D-3129-ABE1-A83A69A8B4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E01D95-DA54-5666-5F6B-FD4C3439B0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ECDC43-3F26-D95E-3BF8-E9107EE6C6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0378AEF-FAAB-5F8C-A401-2EF4E41822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AFF32B-9C64-8049-5989-2678315F84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CAF706-2F13-B1FC-B7C7-5A535361BD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40774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03313D-A655-A393-8D90-F1E021DF3F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E99063B-D626-CEDB-291E-F2B02206BD0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427751-3844-9BBA-4566-39F16D060E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416AA6-9F47-BE2E-E868-48F112A43C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B18507-B2E6-4780-4507-164BA30AE2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9EA6BC-FDBA-EC1F-232A-DBCDE8387C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98068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7CBF482-DEE0-E62B-4637-D8CA4364C8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34F2807-0383-6AF7-D086-B342381ECA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8DE6EE-3E6B-E29C-9EA5-A4911B5DF86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012443-6AB0-6F50-F681-E61A77CB35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0A0C8E-71B4-3163-A0A4-7FB27D9A7F2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72721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AC8D9BE-70A0-D6D2-08BD-54E80BF3FAF0}"/>
              </a:ext>
            </a:extLst>
          </p:cNvPr>
          <p:cNvSpPr txBox="1"/>
          <p:nvPr/>
        </p:nvSpPr>
        <p:spPr>
          <a:xfrm>
            <a:off x="330145" y="6202102"/>
            <a:ext cx="116701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b="1" dirty="0"/>
              <a:t>Supplementary Figure S5. </a:t>
            </a:r>
            <a:r>
              <a:rPr lang="en-GB" sz="1400" dirty="0"/>
              <a:t>Alpha diversity at baseline, three months, and twelve months, stratified by HPV status at 12 months. No significant differences were observed at three or twelve months between HPV-negative and HPV-positive women (Mann-Whitney test, P &gt; 0.05).</a:t>
            </a:r>
            <a:endParaRPr lang="fr-FR" sz="1400" dirty="0"/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6BE0DB56-A0FD-32DF-7625-7D3333CCE68B}"/>
              </a:ext>
            </a:extLst>
          </p:cNvPr>
          <p:cNvGrpSpPr/>
          <p:nvPr/>
        </p:nvGrpSpPr>
        <p:grpSpPr>
          <a:xfrm>
            <a:off x="2387290" y="150520"/>
            <a:ext cx="6867242" cy="5745953"/>
            <a:chOff x="2387290" y="150520"/>
            <a:chExt cx="6867242" cy="5745953"/>
          </a:xfrm>
        </p:grpSpPr>
        <p:pic>
          <p:nvPicPr>
            <p:cNvPr id="5" name="Picture 4" descr="A graph of different colored boxes&#10;&#10;AI-generated content may be incorrect.">
              <a:extLst>
                <a:ext uri="{FF2B5EF4-FFF2-40B4-BE49-F238E27FC236}">
                  <a16:creationId xmlns:a16="http://schemas.microsoft.com/office/drawing/2014/main" id="{A71ECCB6-8381-0334-BDCF-02528BE864C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992"/>
            <a:stretch/>
          </p:blipFill>
          <p:spPr>
            <a:xfrm>
              <a:off x="2387290" y="1022729"/>
              <a:ext cx="6867242" cy="4873744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E8E85328-58D8-8128-AC67-38796D96DA91}"/>
                </a:ext>
              </a:extLst>
            </p:cNvPr>
            <p:cNvSpPr txBox="1"/>
            <p:nvPr/>
          </p:nvSpPr>
          <p:spPr>
            <a:xfrm>
              <a:off x="2790334" y="150520"/>
              <a:ext cx="3177799" cy="400110"/>
            </a:xfrm>
            <a:prstGeom prst="rect">
              <a:avLst/>
            </a:prstGeom>
            <a:solidFill>
              <a:schemeClr val="bg2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000" b="1" dirty="0"/>
                <a:t>HPV-negative women</a:t>
              </a:r>
              <a:endParaRPr lang="fr-FR" sz="2000" b="1" dirty="0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B2CD9FB2-9DA4-F46A-037D-46D84C2C6FE7}"/>
                </a:ext>
              </a:extLst>
            </p:cNvPr>
            <p:cNvSpPr txBox="1"/>
            <p:nvPr/>
          </p:nvSpPr>
          <p:spPr>
            <a:xfrm>
              <a:off x="6014301" y="150520"/>
              <a:ext cx="3177799" cy="400110"/>
            </a:xfrm>
            <a:prstGeom prst="rect">
              <a:avLst/>
            </a:prstGeom>
            <a:solidFill>
              <a:schemeClr val="bg2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2000" b="1" dirty="0"/>
                <a:t>HPV-positive women</a:t>
              </a:r>
              <a:endParaRPr lang="fr-FR" sz="2000" b="1" dirty="0"/>
            </a:p>
          </p:txBody>
        </p:sp>
        <p:sp>
          <p:nvSpPr>
            <p:cNvPr id="6" name="Left Bracket 5">
              <a:extLst>
                <a:ext uri="{FF2B5EF4-FFF2-40B4-BE49-F238E27FC236}">
                  <a16:creationId xmlns:a16="http://schemas.microsoft.com/office/drawing/2014/main" id="{B89F74EE-8FBD-9C0E-338F-27CA420C8CEC}"/>
                </a:ext>
              </a:extLst>
            </p:cNvPr>
            <p:cNvSpPr/>
            <p:nvPr/>
          </p:nvSpPr>
          <p:spPr>
            <a:xfrm rot="5400000">
              <a:off x="6952577" y="-822845"/>
              <a:ext cx="57777" cy="3231554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97B9A7F-2111-8ECA-4B64-ED1718103B1C}"/>
                </a:ext>
              </a:extLst>
            </p:cNvPr>
            <p:cNvSpPr txBox="1"/>
            <p:nvPr/>
          </p:nvSpPr>
          <p:spPr>
            <a:xfrm>
              <a:off x="6746275" y="444604"/>
              <a:ext cx="46679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000" b="1" dirty="0"/>
                <a:t>ns</a:t>
              </a:r>
              <a:endParaRPr lang="fr-FR" sz="2000" b="1" dirty="0"/>
            </a:p>
          </p:txBody>
        </p:sp>
        <p:sp>
          <p:nvSpPr>
            <p:cNvPr id="8" name="Left Bracket 7">
              <a:extLst>
                <a:ext uri="{FF2B5EF4-FFF2-40B4-BE49-F238E27FC236}">
                  <a16:creationId xmlns:a16="http://schemas.microsoft.com/office/drawing/2014/main" id="{43005EC4-B782-BA1E-4B26-828BE71177C6}"/>
                </a:ext>
              </a:extLst>
            </p:cNvPr>
            <p:cNvSpPr/>
            <p:nvPr/>
          </p:nvSpPr>
          <p:spPr>
            <a:xfrm rot="5400000">
              <a:off x="5954906" y="-586204"/>
              <a:ext cx="57777" cy="3231554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70C77E7-DCEC-EC01-8628-0F2445F100A8}"/>
                </a:ext>
              </a:extLst>
            </p:cNvPr>
            <p:cNvSpPr txBox="1"/>
            <p:nvPr/>
          </p:nvSpPr>
          <p:spPr>
            <a:xfrm>
              <a:off x="5748604" y="681245"/>
              <a:ext cx="46679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000" b="1" dirty="0"/>
                <a:t>ns</a:t>
              </a:r>
              <a:endParaRPr lang="fr-FR" sz="20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5713893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5</TotalTime>
  <Words>53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>IAR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rik Gheit</dc:creator>
  <cp:lastModifiedBy>Arun Sharma</cp:lastModifiedBy>
  <cp:revision>23</cp:revision>
  <dcterms:created xsi:type="dcterms:W3CDTF">2025-02-21T17:56:07Z</dcterms:created>
  <dcterms:modified xsi:type="dcterms:W3CDTF">2025-07-07T08:25:01Z</dcterms:modified>
</cp:coreProperties>
</file>